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260" r:id="rId5"/>
  </p:sldIdLst>
  <p:sldSz cx="9906000" cy="6858000" type="A4"/>
  <p:notesSz cx="6784975" cy="9906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eus Cantarino" initials="NC" lastIdx="5" clrIdx="0">
    <p:extLst>
      <p:ext uri="{19B8F6BF-5375-455C-9EA6-DF929625EA0E}">
        <p15:presenceInfo xmlns:p15="http://schemas.microsoft.com/office/powerpoint/2012/main" userId="840306c691ca3d1a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5A6EF"/>
    <a:srgbClr val="8BC5FF"/>
    <a:srgbClr val="F08080"/>
    <a:srgbClr val="EC5E5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658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1506" y="108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commentAuthors" Target="commentAuthors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ercedes Nuñez" userId="0c615336-1165-41a8-8fc1-d7cf3e5b365f" providerId="ADAL" clId="{0DF96488-1E9C-4F51-8A8A-70C4A388875F}"/>
    <pc:docChg chg="custSel modSld">
      <pc:chgData name="Mercedes Nuñez" userId="0c615336-1165-41a8-8fc1-d7cf3e5b365f" providerId="ADAL" clId="{0DF96488-1E9C-4F51-8A8A-70C4A388875F}" dt="2022-06-21T07:14:51.011" v="6" actId="1076"/>
      <pc:docMkLst>
        <pc:docMk/>
      </pc:docMkLst>
      <pc:sldChg chg="delSp modSp mod">
        <pc:chgData name="Mercedes Nuñez" userId="0c615336-1165-41a8-8fc1-d7cf3e5b365f" providerId="ADAL" clId="{0DF96488-1E9C-4F51-8A8A-70C4A388875F}" dt="2022-06-21T07:14:51.011" v="6" actId="1076"/>
        <pc:sldMkLst>
          <pc:docMk/>
          <pc:sldMk cId="1858029731" sldId="260"/>
        </pc:sldMkLst>
        <pc:spChg chg="del">
          <ac:chgData name="Mercedes Nuñez" userId="0c615336-1165-41a8-8fc1-d7cf3e5b365f" providerId="ADAL" clId="{0DF96488-1E9C-4F51-8A8A-70C4A388875F}" dt="2022-06-10T07:25:23.622" v="0" actId="478"/>
          <ac:spMkLst>
            <pc:docMk/>
            <pc:sldMk cId="1858029731" sldId="260"/>
            <ac:spMk id="4" creationId="{A7D38B4E-EDEA-45A2-BDAD-D12D2725BD91}"/>
          </ac:spMkLst>
        </pc:spChg>
        <pc:spChg chg="del">
          <ac:chgData name="Mercedes Nuñez" userId="0c615336-1165-41a8-8fc1-d7cf3e5b365f" providerId="ADAL" clId="{0DF96488-1E9C-4F51-8A8A-70C4A388875F}" dt="2022-06-10T07:27:32.464" v="1" actId="478"/>
          <ac:spMkLst>
            <pc:docMk/>
            <pc:sldMk cId="1858029731" sldId="260"/>
            <ac:spMk id="21" creationId="{5F7E808D-AD34-4AE9-AD57-4A20D53E25BA}"/>
          </ac:spMkLst>
        </pc:spChg>
        <pc:grpChg chg="mod">
          <ac:chgData name="Mercedes Nuñez" userId="0c615336-1165-41a8-8fc1-d7cf3e5b365f" providerId="ADAL" clId="{0DF96488-1E9C-4F51-8A8A-70C4A388875F}" dt="2022-06-21T07:14:42.339" v="4" actId="1076"/>
          <ac:grpSpMkLst>
            <pc:docMk/>
            <pc:sldMk cId="1858029731" sldId="260"/>
            <ac:grpSpMk id="9" creationId="{727A7C0C-F377-4D7D-92FE-C9669D686388}"/>
          </ac:grpSpMkLst>
        </pc:grpChg>
        <pc:grpChg chg="mod">
          <ac:chgData name="Mercedes Nuñez" userId="0c615336-1165-41a8-8fc1-d7cf3e5b365f" providerId="ADAL" clId="{0DF96488-1E9C-4F51-8A8A-70C4A388875F}" dt="2022-06-21T07:14:51.011" v="6" actId="1076"/>
          <ac:grpSpMkLst>
            <pc:docMk/>
            <pc:sldMk cId="1858029731" sldId="260"/>
            <ac:grpSpMk id="16" creationId="{42602B1B-CFD7-4B2F-808C-5FA26BC9B4CA}"/>
          </ac:grpSpMkLst>
        </pc:grpChg>
        <pc:picChg chg="mod">
          <ac:chgData name="Mercedes Nuñez" userId="0c615336-1165-41a8-8fc1-d7cf3e5b365f" providerId="ADAL" clId="{0DF96488-1E9C-4F51-8A8A-70C4A388875F}" dt="2022-06-21T07:14:45.730" v="5" actId="1076"/>
          <ac:picMkLst>
            <pc:docMk/>
            <pc:sldMk cId="1858029731" sldId="260"/>
            <ac:picMk id="8" creationId="{C28227C6-1062-40F0-8F17-0BF0338C3D8D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1DCF4-029D-42E8-8C16-B7FF8DD8AD75}" type="datetimeFigureOut">
              <a:rPr lang="es-ES" smtClean="0"/>
              <a:t>21/06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1AE0-044E-47D0-B5F0-0F54AD1E921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58621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1DCF4-029D-42E8-8C16-B7FF8DD8AD75}" type="datetimeFigureOut">
              <a:rPr lang="es-ES" smtClean="0"/>
              <a:t>21/06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1AE0-044E-47D0-B5F0-0F54AD1E921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961787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1DCF4-029D-42E8-8C16-B7FF8DD8AD75}" type="datetimeFigureOut">
              <a:rPr lang="es-ES" smtClean="0"/>
              <a:t>21/06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1AE0-044E-47D0-B5F0-0F54AD1E921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910350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1DCF4-029D-42E8-8C16-B7FF8DD8AD75}" type="datetimeFigureOut">
              <a:rPr lang="es-ES" smtClean="0"/>
              <a:t>21/06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1AE0-044E-47D0-B5F0-0F54AD1E921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586377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1DCF4-029D-42E8-8C16-B7FF8DD8AD75}" type="datetimeFigureOut">
              <a:rPr lang="es-ES" smtClean="0"/>
              <a:t>21/06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1AE0-044E-47D0-B5F0-0F54AD1E921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676642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1DCF4-029D-42E8-8C16-B7FF8DD8AD75}" type="datetimeFigureOut">
              <a:rPr lang="es-ES" smtClean="0"/>
              <a:t>21/06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1AE0-044E-47D0-B5F0-0F54AD1E921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05645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1DCF4-029D-42E8-8C16-B7FF8DD8AD75}" type="datetimeFigureOut">
              <a:rPr lang="es-ES" smtClean="0"/>
              <a:t>21/06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1AE0-044E-47D0-B5F0-0F54AD1E921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932666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1DCF4-029D-42E8-8C16-B7FF8DD8AD75}" type="datetimeFigureOut">
              <a:rPr lang="es-ES" smtClean="0"/>
              <a:t>21/06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1AE0-044E-47D0-B5F0-0F54AD1E921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349732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1DCF4-029D-42E8-8C16-B7FF8DD8AD75}" type="datetimeFigureOut">
              <a:rPr lang="es-ES" smtClean="0"/>
              <a:t>21/06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1AE0-044E-47D0-B5F0-0F54AD1E921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50076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1DCF4-029D-42E8-8C16-B7FF8DD8AD75}" type="datetimeFigureOut">
              <a:rPr lang="es-ES" smtClean="0"/>
              <a:t>21/06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1AE0-044E-47D0-B5F0-0F54AD1E921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784569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1DCF4-029D-42E8-8C16-B7FF8DD8AD75}" type="datetimeFigureOut">
              <a:rPr lang="es-ES" smtClean="0"/>
              <a:t>21/06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F31AE0-044E-47D0-B5F0-0F54AD1E921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601833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A1DCF4-029D-42E8-8C16-B7FF8DD8AD75}" type="datetimeFigureOut">
              <a:rPr lang="es-ES" smtClean="0"/>
              <a:t>21/06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F31AE0-044E-47D0-B5F0-0F54AD1E921C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734673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Rectangle 22">
            <a:extLst>
              <a:ext uri="{FF2B5EF4-FFF2-40B4-BE49-F238E27FC236}">
                <a16:creationId xmlns:a16="http://schemas.microsoft.com/office/drawing/2014/main" id="{35E9713C-54BC-4E6E-82B7-161F634808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79078" y="83599"/>
            <a:ext cx="127913" cy="1493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63306" tIns="31652" rIns="63306" bIns="31652" numCol="1" anchor="ctr" anchorCtr="0" compatLnSpc="1">
            <a:prstTxWarp prst="textNoShape">
              <a:avLst/>
            </a:prstTxWarp>
            <a:spAutoFit/>
          </a:bodyPr>
          <a:lstStyle/>
          <a:p>
            <a:endParaRPr lang="es-ES" sz="555"/>
          </a:p>
        </p:txBody>
      </p:sp>
      <p:pic>
        <p:nvPicPr>
          <p:cNvPr id="8" name="Imagen 7" descr="Gráfico, Gráfico de líneas&#10;&#10;Descripción generada automáticamente">
            <a:extLst>
              <a:ext uri="{FF2B5EF4-FFF2-40B4-BE49-F238E27FC236}">
                <a16:creationId xmlns:a16="http://schemas.microsoft.com/office/drawing/2014/main" id="{C28227C6-1062-40F0-8F17-0BF0338C3D8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3617" r="5520" b="3005"/>
          <a:stretch/>
        </p:blipFill>
        <p:spPr>
          <a:xfrm>
            <a:off x="1305654" y="520934"/>
            <a:ext cx="6942336" cy="5228381"/>
          </a:xfrm>
          <a:prstGeom prst="rect">
            <a:avLst/>
          </a:prstGeom>
        </p:spPr>
      </p:pic>
      <p:grpSp>
        <p:nvGrpSpPr>
          <p:cNvPr id="9" name="Grupo 8">
            <a:extLst>
              <a:ext uri="{FF2B5EF4-FFF2-40B4-BE49-F238E27FC236}">
                <a16:creationId xmlns:a16="http://schemas.microsoft.com/office/drawing/2014/main" id="{727A7C0C-F377-4D7D-92FE-C9669D686388}"/>
              </a:ext>
            </a:extLst>
          </p:cNvPr>
          <p:cNvGrpSpPr/>
          <p:nvPr/>
        </p:nvGrpSpPr>
        <p:grpSpPr>
          <a:xfrm>
            <a:off x="2476695" y="6160429"/>
            <a:ext cx="2300127" cy="603073"/>
            <a:chOff x="645227" y="3853021"/>
            <a:chExt cx="2300127" cy="603073"/>
          </a:xfrm>
        </p:grpSpPr>
        <p:sp>
          <p:nvSpPr>
            <p:cNvPr id="11" name="CuadroTexto 10">
              <a:extLst>
                <a:ext uri="{FF2B5EF4-FFF2-40B4-BE49-F238E27FC236}">
                  <a16:creationId xmlns:a16="http://schemas.microsoft.com/office/drawing/2014/main" id="{A3215AD1-BF86-4F00-8AE0-9FEC318484E8}"/>
                </a:ext>
              </a:extLst>
            </p:cNvPr>
            <p:cNvSpPr txBox="1"/>
            <p:nvPr/>
          </p:nvSpPr>
          <p:spPr>
            <a:xfrm>
              <a:off x="954033" y="4055984"/>
              <a:ext cx="199132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Second line of treatment</a:t>
              </a:r>
              <a:endParaRPr lang="en-GB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E8FFC16C-1123-499E-8A91-E2AD81E06D6D}"/>
                </a:ext>
              </a:extLst>
            </p:cNvPr>
            <p:cNvSpPr txBox="1"/>
            <p:nvPr/>
          </p:nvSpPr>
          <p:spPr>
            <a:xfrm>
              <a:off x="966996" y="3853021"/>
              <a:ext cx="19658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First line of treatment</a:t>
              </a:r>
              <a:endParaRPr lang="es-E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" name="Conector recto 12">
              <a:extLst>
                <a:ext uri="{FF2B5EF4-FFF2-40B4-BE49-F238E27FC236}">
                  <a16:creationId xmlns:a16="http://schemas.microsoft.com/office/drawing/2014/main" id="{3DBD1EF4-B6FA-4672-ABA2-DC1153F48CA2}"/>
                </a:ext>
              </a:extLst>
            </p:cNvPr>
            <p:cNvCxnSpPr>
              <a:cxnSpLocks/>
            </p:cNvCxnSpPr>
            <p:nvPr/>
          </p:nvCxnSpPr>
          <p:spPr>
            <a:xfrm>
              <a:off x="645227" y="3976130"/>
              <a:ext cx="321769" cy="0"/>
            </a:xfrm>
            <a:prstGeom prst="line">
              <a:avLst/>
            </a:prstGeom>
            <a:ln w="28575">
              <a:solidFill>
                <a:srgbClr val="011EAF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Conector recto 14">
              <a:extLst>
                <a:ext uri="{FF2B5EF4-FFF2-40B4-BE49-F238E27FC236}">
                  <a16:creationId xmlns:a16="http://schemas.microsoft.com/office/drawing/2014/main" id="{096A951B-A143-4018-8536-91A8D6C97F9A}"/>
                </a:ext>
              </a:extLst>
            </p:cNvPr>
            <p:cNvCxnSpPr>
              <a:cxnSpLocks/>
            </p:cNvCxnSpPr>
            <p:nvPr/>
          </p:nvCxnSpPr>
          <p:spPr>
            <a:xfrm>
              <a:off x="645227" y="4181870"/>
              <a:ext cx="321769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6" name="Grupo 15">
            <a:extLst>
              <a:ext uri="{FF2B5EF4-FFF2-40B4-BE49-F238E27FC236}">
                <a16:creationId xmlns:a16="http://schemas.microsoft.com/office/drawing/2014/main" id="{42602B1B-CFD7-4B2F-808C-5FA26BC9B4CA}"/>
              </a:ext>
            </a:extLst>
          </p:cNvPr>
          <p:cNvGrpSpPr/>
          <p:nvPr/>
        </p:nvGrpSpPr>
        <p:grpSpPr>
          <a:xfrm>
            <a:off x="5947649" y="6160429"/>
            <a:ext cx="2300341" cy="603073"/>
            <a:chOff x="645013" y="3853021"/>
            <a:chExt cx="2300341" cy="603073"/>
          </a:xfrm>
        </p:grpSpPr>
        <p:sp>
          <p:nvSpPr>
            <p:cNvPr id="17" name="CuadroTexto 16">
              <a:extLst>
                <a:ext uri="{FF2B5EF4-FFF2-40B4-BE49-F238E27FC236}">
                  <a16:creationId xmlns:a16="http://schemas.microsoft.com/office/drawing/2014/main" id="{288574DB-A70D-438C-B39F-DE70576093BB}"/>
                </a:ext>
              </a:extLst>
            </p:cNvPr>
            <p:cNvSpPr txBox="1"/>
            <p:nvPr/>
          </p:nvSpPr>
          <p:spPr>
            <a:xfrm>
              <a:off x="954033" y="4055984"/>
              <a:ext cx="199132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cs typeface="Arial" panose="020B0604020202020204" pitchFamily="34" charset="0"/>
                </a:rPr>
                <a:t>Discontinuation</a:t>
              </a:r>
              <a:endParaRPr lang="en-GB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BBD7D78B-279A-4CBD-9842-298D8FDAC618}"/>
                </a:ext>
              </a:extLst>
            </p:cNvPr>
            <p:cNvSpPr txBox="1"/>
            <p:nvPr/>
          </p:nvSpPr>
          <p:spPr>
            <a:xfrm>
              <a:off x="966782" y="3853021"/>
              <a:ext cx="19658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Third line of treatment</a:t>
              </a:r>
              <a:endParaRPr lang="es-E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9" name="Conector recto 18">
              <a:extLst>
                <a:ext uri="{FF2B5EF4-FFF2-40B4-BE49-F238E27FC236}">
                  <a16:creationId xmlns:a16="http://schemas.microsoft.com/office/drawing/2014/main" id="{4EF969BB-292B-4A43-A0FC-E88A56E44102}"/>
                </a:ext>
              </a:extLst>
            </p:cNvPr>
            <p:cNvCxnSpPr>
              <a:cxnSpLocks/>
            </p:cNvCxnSpPr>
            <p:nvPr/>
          </p:nvCxnSpPr>
          <p:spPr>
            <a:xfrm>
              <a:off x="645227" y="3976130"/>
              <a:ext cx="321769" cy="0"/>
            </a:xfrm>
            <a:prstGeom prst="line">
              <a:avLst/>
            </a:prstGeom>
            <a:ln w="28575">
              <a:solidFill>
                <a:srgbClr val="CC0000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0" name="Conector recto 19">
              <a:extLst>
                <a:ext uri="{FF2B5EF4-FFF2-40B4-BE49-F238E27FC236}">
                  <a16:creationId xmlns:a16="http://schemas.microsoft.com/office/drawing/2014/main" id="{9D7DEAE6-FEC4-471A-A071-F96527AB290F}"/>
                </a:ext>
              </a:extLst>
            </p:cNvPr>
            <p:cNvCxnSpPr>
              <a:cxnSpLocks/>
            </p:cNvCxnSpPr>
            <p:nvPr/>
          </p:nvCxnSpPr>
          <p:spPr>
            <a:xfrm>
              <a:off x="645013" y="4182166"/>
              <a:ext cx="321769" cy="0"/>
            </a:xfrm>
            <a:prstGeom prst="line">
              <a:avLst/>
            </a:prstGeom>
            <a:ln w="28575">
              <a:solidFill>
                <a:srgbClr val="0CD22D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85802973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c28e5d12-394b-4923-aa6d-0d2c38060489" xsi:nil="true"/>
    <lcf76f155ced4ddcb4097134ff3c332f xmlns="4ec3dfba-4bc2-48f4-9cfa-eb0df8aa5a52">
      <Terms xmlns="http://schemas.microsoft.com/office/infopath/2007/PartnerControls"/>
    </lcf76f155ced4ddcb4097134ff3c332f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00952301C1CD554194BF2602743EEB30" ma:contentTypeVersion="16" ma:contentTypeDescription="Crear nuevo documento." ma:contentTypeScope="" ma:versionID="b8fd4c55ef163ddc406a7e484377b46a">
  <xsd:schema xmlns:xsd="http://www.w3.org/2001/XMLSchema" xmlns:xs="http://www.w3.org/2001/XMLSchema" xmlns:p="http://schemas.microsoft.com/office/2006/metadata/properties" xmlns:ns2="4ec3dfba-4bc2-48f4-9cfa-eb0df8aa5a52" xmlns:ns3="c28e5d12-394b-4923-aa6d-0d2c38060489" targetNamespace="http://schemas.microsoft.com/office/2006/metadata/properties" ma:root="true" ma:fieldsID="8ebb0ec8853e11908036a34dd2bdc260" ns2:_="" ns3:_="">
    <xsd:import namespace="4ec3dfba-4bc2-48f4-9cfa-eb0df8aa5a52"/>
    <xsd:import namespace="c28e5d12-394b-4923-aa6d-0d2c38060489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DateTaken" minOccurs="0"/>
                <xsd:element ref="ns2:MediaServiceAutoTags" minOccurs="0"/>
                <xsd:element ref="ns2:MediaServiceOCR" minOccurs="0"/>
                <xsd:element ref="ns2:MediaServiceLocation" minOccurs="0"/>
                <xsd:element ref="ns3:SharedWithUsers" minOccurs="0"/>
                <xsd:element ref="ns3:SharedWithDetails" minOccurs="0"/>
                <xsd:element ref="ns2:MediaServiceGenerationTime" minOccurs="0"/>
                <xsd:element ref="ns2:MediaServiceEventHashCode" minOccurs="0"/>
                <xsd:element ref="ns2:MediaLengthInSeconds" minOccurs="0"/>
                <xsd:element ref="ns2:lcf76f155ced4ddcb4097134ff3c332f" minOccurs="0"/>
                <xsd:element ref="ns3:TaxCatchAll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ec3dfba-4bc2-48f4-9cfa-eb0df8aa5a5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5" nillable="true" ma:displayName="Location" ma:internalName="MediaServiceLocation" ma:readOnly="true">
      <xsd:simpleType>
        <xsd:restriction base="dms:Text"/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20" nillable="true" ma:displayName="Length (seconds)" ma:internalName="MediaLengthInSeconds" ma:readOnly="true">
      <xsd:simpleType>
        <xsd:restriction base="dms:Unknown"/>
      </xsd:simpleType>
    </xsd:element>
    <xsd:element name="lcf76f155ced4ddcb4097134ff3c332f" ma:index="22" nillable="true" ma:taxonomy="true" ma:internalName="lcf76f155ced4ddcb4097134ff3c332f" ma:taxonomyFieldName="MediaServiceImageTags" ma:displayName="Etiquetas de imagen" ma:readOnly="false" ma:fieldId="{5cf76f15-5ced-4ddc-b409-7134ff3c332f}" ma:taxonomyMulti="true" ma:sspId="f9adb9bf-65a7-4dcd-b9fe-2cabe70ed69e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c28e5d12-394b-4923-aa6d-0d2c38060489" elementFormDefault="qualified">
    <xsd:import namespace="http://schemas.microsoft.com/office/2006/documentManagement/types"/>
    <xsd:import namespace="http://schemas.microsoft.com/office/infopath/2007/PartnerControls"/>
    <xsd:element name="SharedWithUsers" ma:index="16" nillable="true" ma:displayName="Compartid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7" nillable="true" ma:displayName="Detalles de uso compartido" ma:internalName="SharedWithDetails" ma:readOnly="true">
      <xsd:simpleType>
        <xsd:restriction base="dms:Note">
          <xsd:maxLength value="255"/>
        </xsd:restriction>
      </xsd:simpleType>
    </xsd:element>
    <xsd:element name="TaxCatchAll" ma:index="23" nillable="true" ma:displayName="Taxonomy Catch All Column" ma:hidden="true" ma:list="{ef5938de-6906-44a9-b0cc-1376f839682e}" ma:internalName="TaxCatchAll" ma:showField="CatchAllData" ma:web="c28e5d12-394b-4923-aa6d-0d2c3806048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ni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9A940BA3-01F2-4235-A65F-BE4EB4C446A0}">
  <ds:schemaRefs>
    <ds:schemaRef ds:uri="http://schemas.microsoft.com/office/2006/metadata/properties"/>
    <ds:schemaRef ds:uri="http://schemas.microsoft.com/office/infopath/2007/PartnerControls"/>
    <ds:schemaRef ds:uri="c28e5d12-394b-4923-aa6d-0d2c38060489"/>
    <ds:schemaRef ds:uri="4ec3dfba-4bc2-48f4-9cfa-eb0df8aa5a52"/>
  </ds:schemaRefs>
</ds:datastoreItem>
</file>

<file path=customXml/itemProps2.xml><?xml version="1.0" encoding="utf-8"?>
<ds:datastoreItem xmlns:ds="http://schemas.openxmlformats.org/officeDocument/2006/customXml" ds:itemID="{845B257B-8A79-47DA-913B-6CE0F6BB217E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B2783740-7A07-47BF-884C-A2A52F4D9C1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ec3dfba-4bc2-48f4-9cfa-eb0df8aa5a52"/>
    <ds:schemaRef ds:uri="c28e5d12-394b-4923-aa6d-0d2c38060489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08</TotalTime>
  <Words>13</Words>
  <Application>Microsoft Office PowerPoint</Application>
  <PresentationFormat>A4 Paper (210x297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Neus Cantarino</dc:creator>
  <cp:lastModifiedBy>Mercedes Nuñez</cp:lastModifiedBy>
  <cp:revision>116</cp:revision>
  <cp:lastPrinted>2021-03-10T19:16:35Z</cp:lastPrinted>
  <dcterms:created xsi:type="dcterms:W3CDTF">2021-01-23T21:22:56Z</dcterms:created>
  <dcterms:modified xsi:type="dcterms:W3CDTF">2022-06-21T07:14:5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0952301C1CD554194BF2602743EEB30</vt:lpwstr>
  </property>
  <property fmtid="{D5CDD505-2E9C-101B-9397-08002B2CF9AE}" pid="3" name="MediaServiceImageTags">
    <vt:lpwstr/>
  </property>
</Properties>
</file>